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30"/>
    <p:restoredTop sz="94659"/>
  </p:normalViewPr>
  <p:slideViewPr>
    <p:cSldViewPr>
      <p:cViewPr>
        <p:scale>
          <a:sx n="87" d="100"/>
          <a:sy n="87" d="100"/>
        </p:scale>
        <p:origin x="1280" y="6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39480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0791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6982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8443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03185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07919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873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5270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66966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87372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68031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FCD37-34A4-4EC6-B513-765FB092571D}" type="datetimeFigureOut">
              <a:rPr lang="en-IN" smtClean="0"/>
              <a:t>14/07/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255DD8-1EAF-4CD4-B471-E845397E9E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4784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9511" y="6003371"/>
            <a:ext cx="8933633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 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iased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fixation of SNPs in the M and V lines. 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) Plot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shows SNPs fixed in favour of S288c or YJM789 in the eight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_5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lines and five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_57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lines.  B) Expected distribution of YJM789 allele frequencies after five generations of meiosis.  The segregation of the S288c and YJM789 SNPs were simulated using the wild-type recombination information for the S288c/YJM789 hybrid.  The plot shows the distribution of SNPs that are YJM789 after five generations of meiosis.  C) Fixed S288c and YJM789 SNPs that are conserved in all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_5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_7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_10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_15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_31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lines. 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548680"/>
            <a:ext cx="7560840" cy="4968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45602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57</TotalTime>
  <Words>108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ISRTVM</dc:creator>
  <cp:lastModifiedBy>Abhishek Dutta</cp:lastModifiedBy>
  <cp:revision>26</cp:revision>
  <dcterms:created xsi:type="dcterms:W3CDTF">2015-06-08T09:59:35Z</dcterms:created>
  <dcterms:modified xsi:type="dcterms:W3CDTF">2017-07-14T18:25:37Z</dcterms:modified>
</cp:coreProperties>
</file>